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14" d="100"/>
          <a:sy n="114" d="100"/>
        </p:scale>
        <p:origin x="40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0E5C1E8-37D2-D454-5259-CCB7FE333A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7FFEA73-38CC-B85F-3705-E0C35D06A9C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737D751-D520-9894-E63F-1F6A48EB9F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3F5A60-B011-DFF4-61DD-2C35CA906E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10CC81-F993-79CD-6892-22D336911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95175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61287A-7E71-2088-F219-F853E99CABC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028ED4-1A2F-FBBD-BF62-007E09BFA9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6E1AB34-6666-B83B-CABB-A82C5A848B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3249DCF-A27D-2F7C-E046-B5A060C98C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23396B6-AB73-ACF7-97AE-C128BF770F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912489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6EEDECE-7A49-7646-9E8F-33A52C8040B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AC74849-D3BB-83DE-269C-F93E7D966D0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AE28786-43CB-489B-7A02-DF9BF17E8D1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AA74AC-C0C2-3322-8A70-BE25EAF565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6BC77D-4001-537A-269E-6642074FC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962404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FFFC47-3D00-8800-2F7D-D42436FC625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A24BE6F-8DB6-1EE5-B0F7-A65DF002A7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1B60D1-7910-AF97-B233-8D1D8A1AE52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E652973-5EEC-066C-FED7-3D6B7E0F81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52BFA28-41D8-8FAA-4F67-2E4545E208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998657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6EB563-A49D-BFD9-4C41-257EE458A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94E1BB9-AA65-1637-521C-2A2E47FA175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DB8B11-0C5A-E01B-A9F7-5D239668D1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B8AA96D-ACBC-AD70-962A-57AA52BE29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EE87ED1-4395-7EA3-B883-94018CBF91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4744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C4C431-3C6C-484F-4C01-69D3507610D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0482A41-4B29-0388-388D-47ABAD793BB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B44390D-1F2B-D96A-111F-810B5F6309C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7DC3A9F-EA8F-88EB-DDEE-463C8544E60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F01B7B8-9B7D-4D02-4A7B-B23A1864C9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E9E87C1-2B92-7743-F128-71613A640C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26906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38FFE66-C7BA-8FBD-EED8-F7FC2ED820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1C8852-B075-BED1-4175-56601433C11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A0F732E-7A90-9835-FD71-364400951E0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635911-9A5F-8062-CE6A-D9BC7AF8010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AEA20F1-DB9E-61BB-417B-5CAB3733EE6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77B2C03-BF4D-5E31-806F-1FAAEA1FE6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BA89161-7D66-F234-38A6-1266B8B555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2E95BFB-4C0E-3CD8-AAE3-2CC564EAB9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908943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2CB85B-A193-6B44-F273-C3FAC72E07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EFC71B9-F5C9-B944-9AE0-6E3B65FFF4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476BD3-FA56-F8BF-CB0A-86BF7DD9EAF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7FDBFCD-ADB8-C7CB-6509-B4EFDEFDB5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271527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7CFAEB3-603F-409B-269F-400F69D3CB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90FB07D-3ECA-6680-5205-8725B25242C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F841E0C-B8E2-B1B0-770E-D944382106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80662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2D44CF-C17C-7F33-85C1-D91BE2C21E3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01B04F6-8C8C-BEE9-42B4-BFE2308AE3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44AF514-00F0-0D5B-3975-AC501E81A6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52E0C4A-52F0-3C60-FBE8-21A1D37B76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C0A3C96-979B-1E96-1205-FC0A631037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7E196F-F258-440F-A843-43432FA690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919124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779D65-42C3-11B1-E6AB-602C888A715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8010839-377A-EC72-6467-3CE46C2D90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7C8E1D3-462E-DD1D-9533-101CE8C6023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00225B1-8B88-D1E0-55AB-5F09884C8B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E073851-DACF-9E39-75E5-BD761B2E6B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53ECCDF-5974-FCB5-1F68-69E83F80F4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4917492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A3E2185-BAF0-0966-DD59-02445D4BD57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90F8D46-0AA3-4FF4-E65C-7A9510E82F0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AF017A3-5693-51BB-80AC-2003E21548C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871B9B-7F08-44A4-B5CB-E4667F751349}" type="datetimeFigureOut">
              <a:rPr lang="en-GB" smtClean="0"/>
              <a:t>02/06/2023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BD5B364-E272-2D61-3FF9-402D26079BC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4AAF152-CB1D-9C75-E202-4EAEE9DD6C4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0A00C0B-3318-4883-B387-997DA06EEA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057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A picture containing application&#10;&#10;Description automatically generated">
            <a:extLst>
              <a:ext uri="{FF2B5EF4-FFF2-40B4-BE49-F238E27FC236}">
                <a16:creationId xmlns:a16="http://schemas.microsoft.com/office/drawing/2014/main" id="{F559CAC1-4015-40B7-9718-B5F9697FD66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19322" y="228711"/>
            <a:ext cx="4753356" cy="4840224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43CA81A-6F6E-D0DC-3AC9-F45600BA85D8}"/>
              </a:ext>
            </a:extLst>
          </p:cNvPr>
          <p:cNvSpPr txBox="1"/>
          <p:nvPr/>
        </p:nvSpPr>
        <p:spPr>
          <a:xfrm>
            <a:off x="1889620" y="5257773"/>
            <a:ext cx="8814732" cy="15388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spcAft>
                <a:spcPts val="565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Supplementary Figure 1. Sema4D stimulates translocation of </a:t>
            </a:r>
            <a:r>
              <a:rPr lang="en-GB" sz="1200" b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RelA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-GFP to the nucleus. 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565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A).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 Representative images of PC3 cells transfected with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RelA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-GFP and treated with Sema4D, (2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Symbol" panose="05050102010706020507" pitchFamily="18" charset="2"/>
                <a:ea typeface="Times New Roman" panose="02020603050405020304" pitchFamily="18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Calibri" panose="020F0502020204030204" pitchFamily="34" charset="0"/>
              </a:rPr>
              <a:t>g/ml), or vehicle (control) for 60 min. The cells were fixed and stained for actin (phalloidin-TRITC) and DNA (DAPI), scale bar 10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Symbol" panose="05050102010706020507" pitchFamily="18" charset="2"/>
                <a:ea typeface="Calibri" panose="020F0502020204030204" pitchFamily="34" charset="0"/>
                <a:cs typeface="Calibri" panose="020F0502020204030204" pitchFamily="34" charset="0"/>
              </a:rPr>
              <a:t>m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.</a:t>
            </a:r>
            <a:endParaRPr lang="en-GB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spcAft>
                <a:spcPts val="800"/>
              </a:spcAft>
            </a:pP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B).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Subcellular localisation of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elA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-GFP in transfected PC3 cells, following treatment with Sema4D. </a:t>
            </a:r>
            <a:r>
              <a:rPr lang="en-GB" sz="1200" b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)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PC3 cells transfected with </a:t>
            </a:r>
            <a:r>
              <a:rPr lang="en-GB" sz="1200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RelA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-GFP were scored blind and categorised into three groups: 1) nuclear staining &gt; cytoplasmic staining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</a:rPr>
              <a:t> (N&gt;C)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, 2) nuclear and cytoplasmic staining equal,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</a:rPr>
              <a:t> (N=C),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 3) cytoplasmic staining&gt; nuclear staining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SimSun" panose="02010600030101010101" pitchFamily="2" charset="-122"/>
              </a:rPr>
              <a:t>(C&gt;N)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and the % of cells in each group scored (n=4). </a:t>
            </a:r>
            <a:r>
              <a:rPr lang="en-GB" sz="1200" b="1" kern="1200" dirty="0" err="1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Ii</a:t>
            </a:r>
            <a:r>
              <a:rPr lang="en-GB" sz="1200" b="1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) 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percentage of cells in which nuclear GFP staining exceeds cytoplasmic GFP staining. Total 510+ cells counted per condition (n=4, *p=&lt;0.05, </a:t>
            </a:r>
            <a:r>
              <a:rPr lang="en-GB" sz="1200" dirty="0"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student T-Test</a:t>
            </a:r>
            <a:r>
              <a:rPr lang="en-GB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Times New Roman" panose="02020603050405020304" pitchFamily="18" charset="0"/>
              </a:rPr>
              <a:t>)</a:t>
            </a:r>
            <a:endParaRPr lang="en-GB" sz="12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5780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0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Theme</vt:lpstr>
      <vt:lpstr>PowerPoint Presentation</vt:lpstr>
    </vt:vector>
  </TitlesOfParts>
  <Company>KC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gali Williamson</dc:creator>
  <cp:lastModifiedBy>Magali Williamson</cp:lastModifiedBy>
  <cp:revision>1</cp:revision>
  <dcterms:created xsi:type="dcterms:W3CDTF">2023-06-02T16:36:01Z</dcterms:created>
  <dcterms:modified xsi:type="dcterms:W3CDTF">2023-06-02T16:36:42Z</dcterms:modified>
</cp:coreProperties>
</file>